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4710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7025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0210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2441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686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3256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2048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493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6416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2082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275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7FDCC1-8BE8-4336-A21F-6B6392166096}" type="datetimeFigureOut">
              <a:rPr lang="ko-KR" altLang="en-US" smtClean="0"/>
              <a:t>2020-09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703F6-01E6-4213-ABE0-55A93A7A99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809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03921" y="273827"/>
            <a:ext cx="41841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Information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398254" y="1508994"/>
            <a:ext cx="11395493" cy="47192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Highly efficient and safe genome editing by CRISPR-Cas12a using CRISPR RNA </a:t>
            </a:r>
          </a:p>
          <a:p>
            <a:pPr algn="ctr">
              <a:lnSpc>
                <a:spcPct val="150000"/>
              </a:lnSpc>
            </a:pP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with a ribosyl-2’-O-methylated </a:t>
            </a:r>
            <a:r>
              <a:rPr lang="en-US" altLang="ko-KR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ridinylate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-rich 3’-overhang in mouse zygotes</a:t>
            </a:r>
          </a:p>
          <a:p>
            <a:pPr algn="ctr">
              <a:lnSpc>
                <a:spcPct val="150000"/>
              </a:lnSpc>
            </a:pPr>
            <a:endParaRPr lang="en-US" altLang="ko-K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Dae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-In Ha</a:t>
            </a:r>
            <a:r>
              <a:rPr lang="en-US" altLang="ko-KR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,2,4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Jeong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Lee</a:t>
            </a:r>
            <a:r>
              <a:rPr lang="en-US" altLang="ko-KR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,2, 4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, Nan-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Ee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Lee</a:t>
            </a:r>
            <a:r>
              <a:rPr lang="en-US" altLang="ko-KR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,2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Daesik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Kim</a:t>
            </a:r>
            <a:r>
              <a:rPr lang="en-US" altLang="ko-KR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Jeong-Heon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r>
              <a:rPr lang="en-US" altLang="ko-KR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,2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, Yong-Sam Kim</a:t>
            </a:r>
            <a:r>
              <a:rPr lang="en-US" altLang="ko-KR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,2,3</a:t>
            </a:r>
            <a:r>
              <a:rPr lang="en-US" altLang="ko-KR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  <a:p>
            <a:pPr algn="ctr">
              <a:lnSpc>
                <a:spcPct val="150000"/>
              </a:lnSpc>
            </a:pPr>
            <a:endParaRPr lang="ko-KR" altLang="ko-KR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49263" latinLnBrk="0"/>
            <a:r>
              <a:rPr lang="en-US" altLang="ko-KR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Genome Editing Research Center, KRIBB, Daejeon 34141, Republic of Korea. </a:t>
            </a:r>
            <a:endParaRPr lang="en-US" altLang="ko-KR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49263" latinLnBrk="0"/>
            <a:r>
              <a:rPr lang="en-US" altLang="ko-KR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KRIBB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chool of Bioscience, Korea University of Science and Technology (UST) 34141, Daejeon, Republic of Korea </a:t>
            </a:r>
            <a:endParaRPr lang="ko-KR" altLang="ko-KR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49263" latinLnBrk="0"/>
            <a:r>
              <a:rPr lang="en-US" altLang="ko-KR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GenKOre, Daejeon 34141, Republic of Korea.</a:t>
            </a:r>
            <a:endParaRPr lang="ko-KR" altLang="ko-KR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49263" latinLnBrk="0"/>
            <a:endParaRPr lang="en-US" altLang="ko-KR" sz="1600" baseline="30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49263" latinLnBrk="0"/>
            <a:r>
              <a:rPr lang="en-US" altLang="ko-KR" sz="1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hese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uthors contributed equally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449263" latinLnBrk="0"/>
            <a:endParaRPr lang="ko-KR" altLang="ko-KR" sz="1600" dirty="0"/>
          </a:p>
          <a:p>
            <a:pPr algn="ctr">
              <a:lnSpc>
                <a:spcPct val="150000"/>
              </a:lnSpc>
            </a:pPr>
            <a:endParaRPr lang="en-US" altLang="ko-KR" sz="1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50000"/>
              </a:lnSpc>
            </a:pPr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-2</a:t>
            </a:r>
          </a:p>
          <a:p>
            <a:pPr algn="ctr">
              <a:lnSpc>
                <a:spcPct val="150000"/>
              </a:lnSpc>
            </a:pPr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-S4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63404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2903" y="157783"/>
            <a:ext cx="9766194" cy="4364344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2903" y="4421753"/>
            <a:ext cx="9766194" cy="1393083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862462" y="6157335"/>
            <a:ext cx="1091531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200" b="1" kern="100" dirty="0">
                <a:latin typeface="Corbel" panose="020B0503020204020204" pitchFamily="34" charset="0"/>
                <a:cs typeface="Times New Roman" panose="02020603050405020304" pitchFamily="18" charset="0"/>
              </a:rPr>
              <a:t>Figure S1. Sequence of the Target containing Template and </a:t>
            </a:r>
            <a:r>
              <a:rPr lang="en-US" altLang="ko-KR" sz="1200" b="1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Primers. </a:t>
            </a:r>
            <a:r>
              <a:rPr lang="en-US" altLang="ko-KR" sz="1200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Human </a:t>
            </a:r>
            <a:r>
              <a:rPr lang="en-US" altLang="ko-KR" sz="1200" kern="100" dirty="0">
                <a:latin typeface="Corbel" panose="020B0503020204020204" pitchFamily="34" charset="0"/>
                <a:cs typeface="Times New Roman" panose="02020603050405020304" pitchFamily="18" charset="0"/>
              </a:rPr>
              <a:t>DNMT1 (a) and mouse Trp53 (b</a:t>
            </a:r>
            <a:r>
              <a:rPr lang="en-US" altLang="ko-KR" sz="1200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), Wnk1 (c), and </a:t>
            </a:r>
            <a:r>
              <a:rPr lang="en-US" altLang="ko-KR" sz="1200" kern="100" dirty="0" err="1" smtClean="0">
                <a:latin typeface="Corbel" panose="020B0503020204020204" pitchFamily="34" charset="0"/>
                <a:cs typeface="Times New Roman" panose="02020603050405020304" pitchFamily="18" charset="0"/>
              </a:rPr>
              <a:t>Ahrr</a:t>
            </a:r>
            <a:r>
              <a:rPr lang="en-US" altLang="ko-KR" sz="1200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 (d) amplicon </a:t>
            </a:r>
            <a:r>
              <a:rPr lang="en-US" altLang="ko-KR" sz="1200" kern="100" dirty="0">
                <a:latin typeface="Corbel" panose="020B0503020204020204" pitchFamily="34" charset="0"/>
                <a:cs typeface="Times New Roman" panose="02020603050405020304" pitchFamily="18" charset="0"/>
              </a:rPr>
              <a:t>sequences </a:t>
            </a:r>
            <a:r>
              <a:rPr lang="en-US" altLang="ko-KR" sz="1200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were noted. Target </a:t>
            </a:r>
            <a:r>
              <a:rPr lang="en-US" altLang="ko-KR" sz="1200" kern="100" dirty="0">
                <a:latin typeface="Corbel" panose="020B0503020204020204" pitchFamily="34" charset="0"/>
                <a:cs typeface="Times New Roman" panose="02020603050405020304" pitchFamily="18" charset="0"/>
              </a:rPr>
              <a:t>sites (pink) and template amplicon primers (orange) </a:t>
            </a:r>
            <a:r>
              <a:rPr lang="en-US" altLang="ko-KR" sz="1200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were included. </a:t>
            </a:r>
            <a:r>
              <a:rPr lang="en-US" altLang="ko-KR" sz="1200" kern="100" dirty="0">
                <a:latin typeface="Corbel" panose="020B0503020204020204" pitchFamily="34" charset="0"/>
                <a:cs typeface="Times New Roman" panose="02020603050405020304" pitchFamily="18" charset="0"/>
              </a:rPr>
              <a:t>NGS amplicon primers (light green) are used </a:t>
            </a:r>
            <a:r>
              <a:rPr lang="en-US" altLang="ko-KR" sz="1200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to amplify templates within an analytical size range.</a:t>
            </a:r>
            <a:endParaRPr lang="ko-KR" altLang="ko-KR" sz="1200" b="1" kern="100" dirty="0">
              <a:latin typeface="Corbel" panose="020B0503020204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014297" y="968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ko-KR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01473" y="130649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ko-KR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14297" y="306315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ko-KR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01473" y="440067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b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ko-KR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76333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530533" y="527831"/>
            <a:ext cx="4801379" cy="53245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</a:t>
            </a:r>
            <a:r>
              <a:rPr lang="en-US" altLang="ko-KR" sz="1000" u="sng" dirty="0">
                <a:solidFill>
                  <a:srgbClr val="000000"/>
                </a:solidFill>
                <a:latin typeface="Courier New" panose="02070309020205020404" pitchFamily="49" charset="0"/>
              </a:rPr>
              <a:t>TTT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CTTCCACCCGGATAAGATGCTGG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AGGAG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altLang="ko-KR" sz="10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Indels</a:t>
            </a:r>
            <a:endParaRPr lang="en-US" altLang="ko-KR" sz="1000" dirty="0" smtClean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pPr algn="r"/>
            <a:endParaRPr lang="en-US" altLang="ko-KR" sz="1000" dirty="0" smtClean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GC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GAGGAGCCAGGCCTAAGAGCAA</a:t>
            </a:r>
            <a:r>
              <a:rPr lang="en-US" altLang="ko-KR" sz="1000" dirty="0" smtClean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-4</a:t>
            </a:r>
            <a:endParaRPr lang="en-US" altLang="ko-KR" dirty="0" smtClean="0"/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TGGGGAGGAG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-5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GGAGGAG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-6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TGGGGAGGAGCCAGGCCTAAGAGCAA</a:t>
            </a:r>
            <a:r>
              <a:rPr lang="en-US" altLang="ko-KR" sz="1000" dirty="0" smtClean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-7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GAGGAG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-8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GAGGAG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 -9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GAGGAG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-13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AGGAG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-1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AG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-17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  -24</a:t>
            </a:r>
          </a:p>
          <a:p>
            <a:pPr algn="r"/>
            <a:endParaRPr lang="en-US" altLang="ko-KR" sz="1000" dirty="0" smtClean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/>
            <a:endParaRPr lang="en-US" altLang="ko-KR" sz="1000" dirty="0" smtClean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</a:t>
            </a:r>
            <a:r>
              <a:rPr lang="en-US" altLang="ko-KR" sz="1000" u="sng" dirty="0">
                <a:solidFill>
                  <a:srgbClr val="000000"/>
                </a:solidFill>
                <a:latin typeface="Courier New" panose="02070309020205020404" pitchFamily="49" charset="0"/>
              </a:rPr>
              <a:t>TTT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CTTCCACCCGGATAAGATGCTGG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AGGAG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altLang="ko-KR" sz="10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Indels</a:t>
            </a:r>
            <a:endParaRPr lang="en-US" altLang="ko-KR" sz="1000" dirty="0" smtClean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/>
            <a:endParaRPr lang="en-US" altLang="ko-KR" sz="100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TGGGGAGGAGCCAGGCCTAAGAGCAA      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-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GGAGGAGCCAGGCCTAAGAGCAA      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-6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AGCCAGGCCTAAGAGCAA      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-8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AGGAGCCAGGCCTAAGAGCAA      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-9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AGCCAGGCCTAAGAGCAA     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-12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C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CAGGCCTAAGAGCAA     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-15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T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CAGGCCTAAGAGCAA     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-15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CT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AGGCCTAAGAGCAA     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-15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CAC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CAGGCCTAAGAGCAA     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-15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GC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15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G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16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16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3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T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3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AGGAG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GG---------T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AA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ATT</a:t>
            </a:r>
            <a:r>
              <a:rPr lang="en-US" altLang="ko-KR" sz="1000" dirty="0" smtClean="0">
                <a:solidFill>
                  <a:srgbClr val="FF0000"/>
                </a:solidFill>
                <a:latin typeface="Courier New" panose="02070309020205020404" pitchFamily="49" charset="0"/>
              </a:rPr>
              <a:t>-C-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AGGAGCCAGGCCTAAGAGCAA     -24</a:t>
            </a:r>
            <a:endParaRPr lang="en-US" altLang="ko-KR" sz="1000" dirty="0" smtClean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5742208" y="527831"/>
            <a:ext cx="4852675" cy="470898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</a:t>
            </a:r>
            <a:r>
              <a:rPr lang="en-US" altLang="ko-KR" sz="1000" u="sng" dirty="0">
                <a:solidFill>
                  <a:srgbClr val="000000"/>
                </a:solidFill>
                <a:latin typeface="Courier New" panose="02070309020205020404" pitchFamily="49" charset="0"/>
              </a:rPr>
              <a:t>TTT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CTTCCACCCGGATAAGATGCTGG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AGGAGCCAGGCCTAAGAGCAA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  <a:r>
              <a:rPr lang="en-US" altLang="ko-KR" sz="10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Indels</a:t>
            </a:r>
            <a:endParaRPr lang="en-US" altLang="ko-KR" sz="1000" dirty="0" smtClean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pPr algn="r"/>
            <a:endParaRPr lang="en-US" altLang="ko-KR" sz="1000" dirty="0" smtClean="0">
              <a:solidFill>
                <a:srgbClr val="000000"/>
              </a:solidFill>
              <a:latin typeface="Courier New" panose="02070309020205020404" pitchFamily="49" charset="0"/>
            </a:endParaRP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GAGGAGCCAGGCCTAAGAGCAA 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GGAGGAGCCAGGCCTAAGAGCAA 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6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G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GAGGAGCCAGGCCTAAGAGCAA 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6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TGGGGAGGAGCCAGGCCTAAGAGCAA 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7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GAGGAGCCAGGCCTAAGAGCAA 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7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AAG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AGGAGCCAGGCCTAAGAGCAA 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7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AG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17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C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G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GGCCTAG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T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AA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A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GCCAGGCCTA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4</a:t>
            </a:r>
          </a:p>
          <a:p>
            <a:pPr algn="r"/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TTTCCTTCCACCCG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</a:rPr>
              <a:t>--------------------------</a:t>
            </a:r>
            <a:r>
              <a:rPr lang="en-US" altLang="ko-KR" sz="1000" dirty="0">
                <a:solidFill>
                  <a:srgbClr val="000000"/>
                </a:solidFill>
                <a:latin typeface="Courier New" panose="02070309020205020404" pitchFamily="49" charset="0"/>
              </a:rPr>
              <a:t>AGAGCAA     -</a:t>
            </a:r>
            <a:r>
              <a:rPr lang="en-US" altLang="ko-KR" sz="10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26</a:t>
            </a:r>
          </a:p>
          <a:p>
            <a:pPr algn="r" fontAlgn="ctr" latinLnBrk="1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TTTCCTTCCACCCGGAT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GAGCAA     -26</a:t>
            </a:r>
            <a:endParaRPr lang="ko-KR" altLang="ko-KR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 fontAlgn="ctr" latinLnBrk="1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TTTCCTTCCACCC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AGAT---------------------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GAGCAA     -26</a:t>
            </a:r>
            <a:endParaRPr lang="ko-KR" altLang="ko-KR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 fontAlgn="ctr" latinLnBrk="1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TTTCCTTCCACCCG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AA--T---------------------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GAGCAA     -26</a:t>
            </a:r>
            <a:endParaRPr lang="ko-KR" altLang="ko-KR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 fontAlgn="ctr" latinLnBrk="1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TTTCCTTCCACCCG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AGG-------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GCAA     -26</a:t>
            </a:r>
            <a:endParaRPr lang="ko-KR" altLang="ko-KR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 fontAlgn="ctr" latinLnBrk="1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TTTCCTTCCACCCG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AT----------------------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GCAA     -26</a:t>
            </a:r>
            <a:endParaRPr lang="ko-KR" altLang="ko-KR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 fontAlgn="ctr" latinLnBrk="1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TTTCCTTCCACCCG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TG-------------------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GCAA     -26</a:t>
            </a:r>
            <a:endParaRPr lang="ko-KR" altLang="ko-KR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 fontAlgn="ctr" latinLnBrk="1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TTTCCTTCCACCCGGAT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GG-------------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GCAA     -26</a:t>
            </a:r>
            <a:endParaRPr lang="ko-KR" altLang="ko-KR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algn="r" fontAlgn="ctr" latinLnBrk="1"/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TTTCCTTCCACCCGGATAA</a:t>
            </a:r>
            <a:r>
              <a:rPr lang="en-US" altLang="ko-KR" sz="10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</a:t>
            </a:r>
            <a:r>
              <a:rPr lang="en-US" altLang="ko-KR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AGCAA     -</a:t>
            </a:r>
            <a:r>
              <a:rPr lang="en-US" altLang="ko-KR" sz="10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6</a:t>
            </a:r>
            <a:endParaRPr lang="ko-KR" altLang="ko-KR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626310" y="6154020"/>
            <a:ext cx="1091531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200" b="1" kern="100" dirty="0">
                <a:latin typeface="Corbel" panose="020B0503020204020204" pitchFamily="34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S2. Alignments of mutation sequences with wild-type ones for </a:t>
            </a:r>
            <a:r>
              <a:rPr lang="en-US" altLang="ko-KR" sz="1200" b="1" kern="100" dirty="0" err="1" smtClean="0">
                <a:latin typeface="Corbel" panose="020B0503020204020204" pitchFamily="34" charset="0"/>
                <a:cs typeface="Times New Roman" panose="02020603050405020304" pitchFamily="18" charset="0"/>
              </a:rPr>
              <a:t>indel</a:t>
            </a:r>
            <a:r>
              <a:rPr lang="en-US" altLang="ko-KR" sz="1200" b="1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 mutation experiments (#4) for Trp53. </a:t>
            </a:r>
            <a:r>
              <a:rPr lang="en-US" altLang="ko-KR" sz="1200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All mutated sequences analyzed by deep sequencing were presented. </a:t>
            </a:r>
            <a:r>
              <a:rPr lang="en-US" altLang="ko-KR" sz="1200" kern="100" dirty="0" err="1" smtClean="0">
                <a:latin typeface="Corbel" panose="020B0503020204020204" pitchFamily="34" charset="0"/>
                <a:cs typeface="Times New Roman" panose="02020603050405020304" pitchFamily="18" charset="0"/>
              </a:rPr>
              <a:t>Protospacer</a:t>
            </a:r>
            <a:r>
              <a:rPr lang="en-US" altLang="ko-KR" sz="1200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 sequence was noted in red letters with an underlined PAM sequence. </a:t>
            </a:r>
            <a:endParaRPr lang="ko-KR" altLang="ko-KR" sz="1200" b="1" kern="100" dirty="0">
              <a:latin typeface="Corbel" panose="020B0503020204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26310" y="250832"/>
            <a:ext cx="2486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Corbel" panose="020B0503020204020204" pitchFamily="34" charset="0"/>
              </a:rPr>
              <a:t>Canonical crRNA: 10 types of reads</a:t>
            </a:r>
            <a:endParaRPr lang="ko-KR" altLang="en-US" sz="1200" b="1" dirty="0">
              <a:latin typeface="Corbel" panose="020B0503020204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00134" y="2436257"/>
            <a:ext cx="2252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Corbel" panose="020B0503020204020204" pitchFamily="34" charset="0"/>
              </a:rPr>
              <a:t>U-rich crRNA: 18 types of reads</a:t>
            </a:r>
            <a:endParaRPr lang="ko-KR" altLang="en-US" sz="1200" b="1" dirty="0">
              <a:latin typeface="Corbel" panose="020B0503020204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900773" y="250832"/>
            <a:ext cx="25221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smtClean="0">
                <a:latin typeface="Corbel" panose="020B0503020204020204" pitchFamily="34" charset="0"/>
              </a:rPr>
              <a:t>OM U-rich crRNA: 27 types of reads</a:t>
            </a:r>
            <a:endParaRPr lang="ko-KR" altLang="en-US" sz="1200" b="1">
              <a:latin typeface="Corbel" panose="020B0503020204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0303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/>
          </p:nvPr>
        </p:nvGraphicFramePr>
        <p:xfrm>
          <a:off x="1870368" y="2302290"/>
          <a:ext cx="8492508" cy="245575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16738">
                  <a:extLst>
                    <a:ext uri="{9D8B030D-6E8A-4147-A177-3AD203B41FA5}">
                      <a16:colId xmlns:a16="http://schemas.microsoft.com/office/drawing/2014/main" val="2723805600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1566806741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1306181124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4270267408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832940237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412827357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3561478145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257077849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512097105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164269043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224564756"/>
                    </a:ext>
                  </a:extLst>
                </a:gridCol>
              </a:tblGrid>
              <a:tr h="298187">
                <a:tc gridSpan="11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rp53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1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3854189"/>
                  </a:ext>
                </a:extLst>
              </a:tr>
              <a:tr h="298187">
                <a:tc row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1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4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5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260901"/>
                  </a:ext>
                </a:extLst>
              </a:tr>
              <a:tr h="29818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(n=50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(n=66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(n=62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(n=22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(n=24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0211396"/>
                  </a:ext>
                </a:extLst>
              </a:tr>
              <a:tr h="46090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ea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ea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ea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dirty="0" err="1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ea</a:t>
                      </a:r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ea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5961649"/>
                  </a:ext>
                </a:extLst>
              </a:tr>
              <a:tr h="36676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Canonical crRNA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ko-KR" altLang="en-US" sz="120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0.00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20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4.54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7.74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ko-KR" altLang="en-US" sz="120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72.73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ko-KR" altLang="en-US" sz="120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62.50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0820508"/>
                  </a:ext>
                </a:extLst>
              </a:tr>
              <a:tr h="36676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U-rich crRNA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120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6.00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altLang="en-US" sz="120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2.12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20.97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ko-KR" altLang="en-US" sz="120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63.64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7</a:t>
                      </a:r>
                      <a:endParaRPr lang="ko-KR" altLang="en-US" sz="120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70.83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5743000"/>
                  </a:ext>
                </a:extLst>
              </a:tr>
              <a:tr h="36676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OM U-rich crRNA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2.00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24.24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120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29.03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120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81.82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22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91.67</a:t>
                      </a:r>
                      <a:endParaRPr lang="ko-KR" altLang="en-US" sz="120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4466602"/>
                  </a:ext>
                </a:extLst>
              </a:tr>
            </a:tbl>
          </a:graphicData>
        </a:graphic>
      </p:graphicFrame>
      <p:sp>
        <p:nvSpPr>
          <p:cNvPr id="3" name="직사각형 2"/>
          <p:cNvSpPr/>
          <p:nvPr/>
        </p:nvSpPr>
        <p:spPr>
          <a:xfrm>
            <a:off x="1786147" y="1637891"/>
            <a:ext cx="842720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/>
            <a:r>
              <a:rPr lang="en-US" altLang="ko-KR" sz="1200" b="1" dirty="0">
                <a:latin typeface="Corbel" panose="020B0503020204020204" pitchFamily="34" charset="0"/>
                <a:cs typeface="Times New Roman" panose="02020603050405020304" pitchFamily="18" charset="0"/>
              </a:rPr>
              <a:t>Table S1. Comparison of 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post-transfection viability of embryos after </a:t>
            </a:r>
            <a:r>
              <a:rPr lang="en-US" altLang="ko-KR" sz="1200" b="1" dirty="0">
                <a:latin typeface="Corbel" panose="020B0503020204020204" pitchFamily="34" charset="0"/>
                <a:cs typeface="Times New Roman" panose="02020603050405020304" pitchFamily="18" charset="0"/>
              </a:rPr>
              <a:t>transfection according to 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the modification types </a:t>
            </a:r>
            <a:r>
              <a:rPr lang="en-US" altLang="ko-KR" sz="1200" b="1">
                <a:latin typeface="Corbel" panose="020B0503020204020204" pitchFamily="34" charset="0"/>
                <a:cs typeface="Times New Roman" panose="02020603050405020304" pitchFamily="18" charset="0"/>
              </a:rPr>
              <a:t>of </a:t>
            </a:r>
            <a:r>
              <a:rPr lang="en-US" altLang="ko-KR" sz="1200" b="1" smtClean="0">
                <a:latin typeface="Corbel" panose="020B0503020204020204" pitchFamily="34" charset="0"/>
                <a:cs typeface="Times New Roman" panose="02020603050405020304" pitchFamily="18" charset="0"/>
              </a:rPr>
              <a:t>crRNA</a:t>
            </a:r>
          </a:p>
          <a:p>
            <a:pPr latinLnBrk="1"/>
            <a:r>
              <a:rPr lang="en-US" altLang="ko-KR" sz="1200" b="1" smtClean="0">
                <a:latin typeface="Corbel" panose="020B0503020204020204" pitchFamily="34" charset="0"/>
                <a:cs typeface="Times New Roman" panose="02020603050405020304" pitchFamily="18" charset="0"/>
              </a:rPr>
              <a:t>in the Trp53 target gene</a:t>
            </a:r>
            <a:endParaRPr lang="ko-KR" altLang="ko-KR" sz="1200" b="1" dirty="0">
              <a:latin typeface="Corbel" panose="020B0503020204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10322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/>
          </p:nvPr>
        </p:nvGraphicFramePr>
        <p:xfrm>
          <a:off x="2467570" y="2362624"/>
          <a:ext cx="7017354" cy="245575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16738">
                  <a:extLst>
                    <a:ext uri="{9D8B030D-6E8A-4147-A177-3AD203B41FA5}">
                      <a16:colId xmlns:a16="http://schemas.microsoft.com/office/drawing/2014/main" val="2723805600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1566806741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1306181124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4270267408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832940237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412827357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3561478145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257077849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512097105"/>
                    </a:ext>
                  </a:extLst>
                </a:gridCol>
              </a:tblGrid>
              <a:tr h="298187">
                <a:tc gridSpan="9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Wnk1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1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3854189"/>
                  </a:ext>
                </a:extLst>
              </a:tr>
              <a:tr h="298187">
                <a:tc row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1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4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260901"/>
                  </a:ext>
                </a:extLst>
              </a:tr>
              <a:tr h="29818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n=28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n=26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n=20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n=20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0211396"/>
                  </a:ext>
                </a:extLst>
              </a:tr>
              <a:tr h="46090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ea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ea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ea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dirty="0" err="1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ea</a:t>
                      </a:r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5961649"/>
                  </a:ext>
                </a:extLst>
              </a:tr>
              <a:tr h="36676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Canonical crRNA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35.7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57.6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40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30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0820508"/>
                  </a:ext>
                </a:extLst>
              </a:tr>
              <a:tr h="36676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U-rich crRNA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35.7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61.5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35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25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5743000"/>
                  </a:ext>
                </a:extLst>
              </a:tr>
              <a:tr h="36676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OM U-rich crRNA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42.8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57.6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45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50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4466602"/>
                  </a:ext>
                </a:extLst>
              </a:tr>
            </a:tbl>
          </a:graphicData>
        </a:graphic>
      </p:graphicFrame>
      <p:sp>
        <p:nvSpPr>
          <p:cNvPr id="6" name="직사각형 5"/>
          <p:cNvSpPr/>
          <p:nvPr/>
        </p:nvSpPr>
        <p:spPr>
          <a:xfrm>
            <a:off x="2363663" y="1806332"/>
            <a:ext cx="71212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/>
            <a:r>
              <a:rPr lang="en-US" altLang="ko-KR" sz="1200" b="1" dirty="0">
                <a:latin typeface="Corbel" panose="020B0503020204020204" pitchFamily="34" charset="0"/>
                <a:cs typeface="Times New Roman" panose="02020603050405020304" pitchFamily="18" charset="0"/>
              </a:rPr>
              <a:t>Table 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S2. </a:t>
            </a:r>
            <a:r>
              <a:rPr lang="en-US" altLang="ko-KR" sz="1200" b="1" dirty="0">
                <a:latin typeface="Corbel" panose="020B0503020204020204" pitchFamily="34" charset="0"/>
                <a:cs typeface="Times New Roman" panose="02020603050405020304" pitchFamily="18" charset="0"/>
              </a:rPr>
              <a:t>Comparison of 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post-transfection viability of embryos after </a:t>
            </a:r>
            <a:r>
              <a:rPr lang="en-US" altLang="ko-KR" sz="1200" b="1" dirty="0">
                <a:latin typeface="Corbel" panose="020B0503020204020204" pitchFamily="34" charset="0"/>
                <a:cs typeface="Times New Roman" panose="02020603050405020304" pitchFamily="18" charset="0"/>
              </a:rPr>
              <a:t>transfection according to 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the modification types </a:t>
            </a:r>
            <a:r>
              <a:rPr lang="en-US" altLang="ko-KR" sz="1200" b="1" dirty="0">
                <a:latin typeface="Corbel" panose="020B0503020204020204" pitchFamily="34" charset="0"/>
                <a:cs typeface="Times New Roman" panose="02020603050405020304" pitchFamily="18" charset="0"/>
              </a:rPr>
              <a:t>of 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crRNA in the Wnk1 target gene</a:t>
            </a:r>
            <a:endParaRPr lang="ko-KR" altLang="ko-KR" sz="1200" b="1" dirty="0">
              <a:latin typeface="Corbel" panose="020B0503020204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86908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/>
          </p:nvPr>
        </p:nvGraphicFramePr>
        <p:xfrm>
          <a:off x="2455538" y="2291640"/>
          <a:ext cx="7017354" cy="245575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16738">
                  <a:extLst>
                    <a:ext uri="{9D8B030D-6E8A-4147-A177-3AD203B41FA5}">
                      <a16:colId xmlns:a16="http://schemas.microsoft.com/office/drawing/2014/main" val="2723805600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1566806741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1306181124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4270267408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832940237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412827357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3561478145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257077849"/>
                    </a:ext>
                  </a:extLst>
                </a:gridCol>
                <a:gridCol w="737577">
                  <a:extLst>
                    <a:ext uri="{9D8B030D-6E8A-4147-A177-3AD203B41FA5}">
                      <a16:colId xmlns:a16="http://schemas.microsoft.com/office/drawing/2014/main" val="2512097105"/>
                    </a:ext>
                  </a:extLst>
                </a:gridCol>
              </a:tblGrid>
              <a:tr h="298187">
                <a:tc gridSpan="9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Ahrr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1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3854189"/>
                  </a:ext>
                </a:extLst>
              </a:tr>
              <a:tr h="298187">
                <a:tc row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1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#4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260901"/>
                  </a:ext>
                </a:extLst>
              </a:tr>
              <a:tr h="298187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n=28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n=26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n=20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n=20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0211396"/>
                  </a:ext>
                </a:extLst>
              </a:tr>
              <a:tr h="460900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ea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ea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ea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orula</a:t>
                      </a:r>
                    </a:p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b="0" dirty="0" err="1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ea</a:t>
                      </a:r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Viability</a:t>
                      </a:r>
                    </a:p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(%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5961649"/>
                  </a:ext>
                </a:extLst>
              </a:tr>
              <a:tr h="36676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Canonical crRNA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34.7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5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25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36.6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0820508"/>
                  </a:ext>
                </a:extLst>
              </a:tr>
              <a:tr h="36676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U-rich crRNA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43.4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20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40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46.6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5743000"/>
                  </a:ext>
                </a:extLst>
              </a:tr>
              <a:tr h="36676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smtClean="0">
                          <a:solidFill>
                            <a:schemeClr val="tx1"/>
                          </a:solidFill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OM U-rich crRNA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Corbel" panose="020B0503020204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52.1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40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50.0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1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rbel" panose="020B0503020204020204" pitchFamily="34" charset="0"/>
                          <a:ea typeface="맑은 고딕" panose="020B0503020000020004" pitchFamily="50" charset="-127"/>
                        </a:rPr>
                        <a:t>63.3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4466602"/>
                  </a:ext>
                </a:extLst>
              </a:tr>
            </a:tbl>
          </a:graphicData>
        </a:graphic>
      </p:graphicFrame>
      <p:sp>
        <p:nvSpPr>
          <p:cNvPr id="3" name="직사각형 2"/>
          <p:cNvSpPr/>
          <p:nvPr/>
        </p:nvSpPr>
        <p:spPr>
          <a:xfrm>
            <a:off x="2339600" y="1734143"/>
            <a:ext cx="728566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/>
            <a:r>
              <a:rPr lang="en-US" altLang="ko-KR" sz="1200" b="1" dirty="0">
                <a:latin typeface="Corbel" panose="020B0503020204020204" pitchFamily="34" charset="0"/>
                <a:cs typeface="Times New Roman" panose="02020603050405020304" pitchFamily="18" charset="0"/>
              </a:rPr>
              <a:t>Table 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S3. </a:t>
            </a:r>
            <a:r>
              <a:rPr lang="en-US" altLang="ko-KR" sz="1200" b="1" dirty="0">
                <a:latin typeface="Corbel" panose="020B0503020204020204" pitchFamily="34" charset="0"/>
                <a:cs typeface="Times New Roman" panose="02020603050405020304" pitchFamily="18" charset="0"/>
              </a:rPr>
              <a:t>Comparison of 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post-transfection viability of embryos after </a:t>
            </a:r>
            <a:r>
              <a:rPr lang="en-US" altLang="ko-KR" sz="1200" b="1" dirty="0">
                <a:latin typeface="Corbel" panose="020B0503020204020204" pitchFamily="34" charset="0"/>
                <a:cs typeface="Times New Roman" panose="02020603050405020304" pitchFamily="18" charset="0"/>
              </a:rPr>
              <a:t>transfection according to 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the modification types </a:t>
            </a:r>
            <a:r>
              <a:rPr lang="en-US" altLang="ko-KR" sz="1200" b="1" dirty="0">
                <a:latin typeface="Corbel" panose="020B0503020204020204" pitchFamily="34" charset="0"/>
                <a:cs typeface="Times New Roman" panose="02020603050405020304" pitchFamily="18" charset="0"/>
              </a:rPr>
              <a:t>of 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crRNA in the </a:t>
            </a:r>
            <a:r>
              <a:rPr lang="en-US" altLang="ko-KR" sz="1200" b="1" dirty="0" err="1" smtClean="0">
                <a:latin typeface="Corbel" panose="020B0503020204020204" pitchFamily="34" charset="0"/>
                <a:cs typeface="Times New Roman" panose="02020603050405020304" pitchFamily="18" charset="0"/>
              </a:rPr>
              <a:t>Ahrr</a:t>
            </a:r>
            <a:r>
              <a:rPr lang="en-US" altLang="ko-KR" sz="1200" b="1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 target gene</a:t>
            </a:r>
            <a:endParaRPr lang="ko-KR" altLang="ko-KR" sz="1200" b="1" dirty="0">
              <a:latin typeface="Corbel" panose="020B0503020204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94737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/>
          </p:nvPr>
        </p:nvGraphicFramePr>
        <p:xfrm>
          <a:off x="1220157" y="2270707"/>
          <a:ext cx="9751686" cy="22884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0057">
                  <a:extLst>
                    <a:ext uri="{9D8B030D-6E8A-4147-A177-3AD203B41FA5}">
                      <a16:colId xmlns:a16="http://schemas.microsoft.com/office/drawing/2014/main" val="1048832343"/>
                    </a:ext>
                  </a:extLst>
                </a:gridCol>
                <a:gridCol w="946937">
                  <a:extLst>
                    <a:ext uri="{9D8B030D-6E8A-4147-A177-3AD203B41FA5}">
                      <a16:colId xmlns:a16="http://schemas.microsoft.com/office/drawing/2014/main" val="2211705352"/>
                    </a:ext>
                  </a:extLst>
                </a:gridCol>
                <a:gridCol w="821644">
                  <a:extLst>
                    <a:ext uri="{9D8B030D-6E8A-4147-A177-3AD203B41FA5}">
                      <a16:colId xmlns:a16="http://schemas.microsoft.com/office/drawing/2014/main" val="3579975183"/>
                    </a:ext>
                  </a:extLst>
                </a:gridCol>
                <a:gridCol w="2241259">
                  <a:extLst>
                    <a:ext uri="{9D8B030D-6E8A-4147-A177-3AD203B41FA5}">
                      <a16:colId xmlns:a16="http://schemas.microsoft.com/office/drawing/2014/main" val="564317708"/>
                    </a:ext>
                  </a:extLst>
                </a:gridCol>
                <a:gridCol w="2241259">
                  <a:extLst>
                    <a:ext uri="{9D8B030D-6E8A-4147-A177-3AD203B41FA5}">
                      <a16:colId xmlns:a16="http://schemas.microsoft.com/office/drawing/2014/main" val="214737358"/>
                    </a:ext>
                  </a:extLst>
                </a:gridCol>
                <a:gridCol w="732633">
                  <a:extLst>
                    <a:ext uri="{9D8B030D-6E8A-4147-A177-3AD203B41FA5}">
                      <a16:colId xmlns:a16="http://schemas.microsoft.com/office/drawing/2014/main" val="2134664821"/>
                    </a:ext>
                  </a:extLst>
                </a:gridCol>
                <a:gridCol w="732633">
                  <a:extLst>
                    <a:ext uri="{9D8B030D-6E8A-4147-A177-3AD203B41FA5}">
                      <a16:colId xmlns:a16="http://schemas.microsoft.com/office/drawing/2014/main" val="3299728196"/>
                    </a:ext>
                  </a:extLst>
                </a:gridCol>
                <a:gridCol w="775152">
                  <a:extLst>
                    <a:ext uri="{9D8B030D-6E8A-4147-A177-3AD203B41FA5}">
                      <a16:colId xmlns:a16="http://schemas.microsoft.com/office/drawing/2014/main" val="14581094"/>
                    </a:ext>
                  </a:extLst>
                </a:gridCol>
                <a:gridCol w="690112">
                  <a:extLst>
                    <a:ext uri="{9D8B030D-6E8A-4147-A177-3AD203B41FA5}">
                      <a16:colId xmlns:a16="http://schemas.microsoft.com/office/drawing/2014/main" val="861735931"/>
                    </a:ext>
                  </a:extLst>
                </a:gridCol>
              </a:tblGrid>
              <a:tr h="263288"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Chromosom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 smtClean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Bulge </a:t>
                      </a:r>
                      <a:r>
                        <a:rPr lang="en-US" sz="1100" b="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crRN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DN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Posi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Direc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Mismatch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Bulge Siz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54917"/>
                  </a:ext>
                </a:extLst>
              </a:tr>
              <a:tr h="2632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OF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chr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R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CCGGATAAGATG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TAAGATG</a:t>
                      </a:r>
                      <a:r>
                        <a:rPr lang="en-US" sz="1100" u="none" strike="noStrike" dirty="0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524940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5822887"/>
                  </a:ext>
                </a:extLst>
              </a:tr>
              <a:tr h="26328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OF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chr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R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CCGGATAAGATG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CC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CGGATAAGAT</a:t>
                      </a:r>
                      <a:r>
                        <a:rPr lang="en-US" sz="1100" u="none" strike="noStrike" dirty="0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 err="1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sz="1100" u="none" strike="noStrike" dirty="0" err="1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4800293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6610246"/>
                  </a:ext>
                </a:extLst>
              </a:tr>
              <a:tr h="26328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D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CCG</a:t>
                      </a:r>
                      <a:r>
                        <a:rPr lang="en-US" sz="1100" u="none" strike="noStrike" dirty="0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TAAGATG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CCGTGGAT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3541981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9864577"/>
                  </a:ext>
                </a:extLst>
              </a:tr>
              <a:tr h="26328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D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CC</a:t>
                      </a:r>
                      <a:r>
                        <a:rPr lang="en-US" sz="1100" u="none" strike="noStrike" dirty="0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ATAAGATG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CCGTGGAT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algn="r" fontAlgn="ctr"/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5951223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OF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chr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R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CCGGATAAGATG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CCACCCtG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ATG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1000433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1204826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OF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chr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X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CCGGATAAGATG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CC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ATAAGATG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5442022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2923855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OF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chr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R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CCGGATAAGATG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TCCAC</a:t>
                      </a:r>
                      <a:r>
                        <a:rPr lang="en-US" sz="1100" u="none" strike="noStrike" dirty="0" err="1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 smtClean="0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sz="1100" u="none" strike="noStrike" dirty="0" smtClean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1100" u="none" strike="noStrike" dirty="0" err="1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AAG</a:t>
                      </a:r>
                      <a:r>
                        <a:rPr lang="en-US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1100" u="none" strike="noStrike" dirty="0" err="1">
                          <a:effectLst/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  <a:cs typeface="Courier New" panose="02070309020205020404" pitchFamily="49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156393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Corbel" panose="020B050302020402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Corbel" panose="020B0503020204020204" pitchFamily="34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8545" marR="8545" marT="854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3828695"/>
                  </a:ext>
                </a:extLst>
              </a:tr>
            </a:tbl>
          </a:graphicData>
        </a:graphic>
      </p:graphicFrame>
      <p:sp>
        <p:nvSpPr>
          <p:cNvPr id="3" name="직사각형 2"/>
          <p:cNvSpPr/>
          <p:nvPr/>
        </p:nvSpPr>
        <p:spPr>
          <a:xfrm>
            <a:off x="1136771" y="1846963"/>
            <a:ext cx="7372350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200" b="1" kern="100" dirty="0">
                <a:latin typeface="Corbel" panose="020B0503020204020204" pitchFamily="34" charset="0"/>
                <a:cs typeface="Times New Roman" panose="02020603050405020304" pitchFamily="18" charset="0"/>
              </a:rPr>
              <a:t>Table </a:t>
            </a:r>
            <a:r>
              <a:rPr lang="en-US" altLang="ko-KR" sz="1200" b="1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S4. </a:t>
            </a:r>
            <a:r>
              <a:rPr lang="en-US" altLang="ko-KR" sz="1200" b="1" kern="100" dirty="0">
                <a:latin typeface="Corbel" panose="020B0503020204020204" pitchFamily="34" charset="0"/>
                <a:cs typeface="Times New Roman" panose="02020603050405020304" pitchFamily="18" charset="0"/>
              </a:rPr>
              <a:t>Potential Off-Target Sites </a:t>
            </a:r>
            <a:r>
              <a:rPr lang="en-US" altLang="ko-KR" sz="1200" b="1" kern="100" dirty="0" smtClean="0">
                <a:latin typeface="Corbel" panose="020B0503020204020204" pitchFamily="34" charset="0"/>
                <a:cs typeface="Times New Roman" panose="02020603050405020304" pitchFamily="18" charset="0"/>
              </a:rPr>
              <a:t>for Trp53 as an on-target</a:t>
            </a:r>
            <a:endParaRPr lang="ko-KR" altLang="ko-KR" sz="1200" b="1" kern="100" dirty="0">
              <a:latin typeface="Corbel" panose="020B0503020204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4108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76</Words>
  <Application>Microsoft Office PowerPoint</Application>
  <PresentationFormat>와이드스크린</PresentationFormat>
  <Paragraphs>329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3" baseType="lpstr">
      <vt:lpstr>맑은 고딕</vt:lpstr>
      <vt:lpstr>Arial</vt:lpstr>
      <vt:lpstr>Corbel</vt:lpstr>
      <vt:lpstr>Courier New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용삼</dc:creator>
  <cp:lastModifiedBy>김용삼</cp:lastModifiedBy>
  <cp:revision>2</cp:revision>
  <dcterms:created xsi:type="dcterms:W3CDTF">2020-09-04T05:40:59Z</dcterms:created>
  <dcterms:modified xsi:type="dcterms:W3CDTF">2020-09-04T05:42:57Z</dcterms:modified>
</cp:coreProperties>
</file>